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7" roundtripDataSignature="AMtx7mi1CRzaniaH8/GJhzJCq56OOXPgi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7F25FC17-D2B2-4892-BD32-7A4E20023F39}">
  <a:tblStyle styleId="{7F25FC17-D2B2-4892-BD32-7A4E20023F39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65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customschemas.google.com/relationships/presentationmetadata" Target="meta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ableStyles" Target="tableStyles.xml"/><Relationship Id="rId10" Type="http://schemas.openxmlformats.org/officeDocument/2006/relationships/theme" Target="theme/theme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e de titre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3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4" name="Google Shape;14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texte vertical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2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vertical et text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3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contenu" type="obj">
  <p:cSld name="OBJEC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de section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5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5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eux contenus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6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7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7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seul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ide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 avec légende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0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0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 avec légende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1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4" name="Google Shape;84;p1"/>
          <p:cNvGraphicFramePr/>
          <p:nvPr>
            <p:extLst>
              <p:ext uri="{D42A27DB-BD31-4B8C-83A1-F6EECF244321}">
                <p14:modId xmlns:p14="http://schemas.microsoft.com/office/powerpoint/2010/main" val="1255490537"/>
              </p:ext>
            </p:extLst>
          </p:nvPr>
        </p:nvGraphicFramePr>
        <p:xfrm>
          <a:off x="429768" y="220725"/>
          <a:ext cx="7818125" cy="6319965"/>
        </p:xfrm>
        <a:graphic>
          <a:graphicData uri="http://schemas.openxmlformats.org/drawingml/2006/table">
            <a:tbl>
              <a:tblPr>
                <a:noFill/>
                <a:tableStyleId>{7F25FC17-D2B2-4892-BD32-7A4E20023F39}</a:tableStyleId>
              </a:tblPr>
              <a:tblGrid>
                <a:gridCol w="441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653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955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7772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6007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0657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08232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8247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10642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435500">
                <a:tc rowSpan="2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field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year of experiment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verage daily air temperature during the cropping season  (°C)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umulative </a:t>
                      </a:r>
                      <a:r>
                        <a:rPr lang="fr-FR" sz="1200" b="0" i="0" u="none" strike="noStrike" cap="none" smtClean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ainfall </a:t>
                      </a:r>
                      <a:r>
                        <a:rPr lang="fr-FR" sz="1200" b="0" i="0" u="none" strike="noStrike" cap="none" dirty="0" err="1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during</a:t>
                      </a:r>
                      <a:r>
                        <a:rPr lang="fr-FR" sz="1200" b="0" i="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 the </a:t>
                      </a:r>
                      <a:r>
                        <a:rPr lang="fr-FR" sz="1200" b="0" i="0" u="none" strike="noStrike" cap="none" dirty="0" err="1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ropping</a:t>
                      </a:r>
                      <a:r>
                        <a:rPr lang="fr-FR" sz="1200" b="0" i="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 </a:t>
                      </a:r>
                      <a:r>
                        <a:rPr lang="fr-FR" sz="1200" b="0" i="0" u="none" strike="noStrike" cap="none" dirty="0" err="1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eason</a:t>
                      </a:r>
                      <a:r>
                        <a:rPr lang="fr-FR" sz="1200" b="0" i="0" u="none" strike="noStrike" cap="none" dirty="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  (mm)</a:t>
                      </a:r>
                      <a:endParaRPr sz="1200" u="none" strike="noStrike" cap="none" dirty="0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verage daily air humidity during the cropping season  (%RH)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umulative global radiation during the cropping season (J cm</a:t>
                      </a:r>
                      <a:r>
                        <a:rPr lang="fr-FR" sz="1200" b="0" i="0" u="none" strike="noStrike" cap="none" baseline="30000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-2</a:t>
                      </a: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)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36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ean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ange (min-max) 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ean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ange (min-max) 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ean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ange (min-max) 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1725">
                <a:tc rowSpan="5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.6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0-28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13.8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3.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7-95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459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87-3084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0.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0-29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48.9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3.0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6-9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390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65-3119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.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-2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50.3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1.8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3-9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420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77-3118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.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0-26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76.3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4.1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8-95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337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22-3083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ean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.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-29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22.3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3.1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7-9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401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65-2401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1725">
                <a:tc rowSpan="5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B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.6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0-2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09.8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3.9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8-95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453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621-3081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0.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0-28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33.5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3.5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7-9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394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67-3118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.2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-26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54.8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2.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4-9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419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77-3118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.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0-26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73.2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4.5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9-95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338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08-3082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ean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.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-28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17.8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3.6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8-9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401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67-3118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71725">
                <a:tc rowSpan="5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8.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-2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87.3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6.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6-92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197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31-3099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8.6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9-25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19.0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7.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64-9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146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16-3143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7.8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-28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16.4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5.1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5-90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142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62-3093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8.5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-2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53.6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6.2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61-9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218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91-3071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ean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8.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-28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44.1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6.2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5-9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176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91-3143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71725">
                <a:tc rowSpan="5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D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8.5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6-2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72.2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0.8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9-100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68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3-2847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.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0-2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49.2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69.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6-92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019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9-2841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0.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0-30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47.6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67.5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6-96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076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74-2916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.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9-2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37.8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66.2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0-9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033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33-2823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ean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.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6-30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76.7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68.5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0-100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014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33-2916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71725">
                <a:tc rowSpan="5"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E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8.5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-2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76.1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4.0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0-90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296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56-3104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8.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-26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00.8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4.9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5-91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225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95-3151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7.8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-2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93.6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2.9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0-90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254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30-3112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8.5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9-26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68.6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3.9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8-9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319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85-3089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717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ean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8.4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-27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84.8</a:t>
                      </a:r>
                      <a:endParaRPr sz="120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3.9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0-93</a:t>
                      </a:r>
                      <a:endParaRPr sz="1200" u="none" strike="noStrike" cap="none"/>
                    </a:p>
                  </a:txBody>
                  <a:tcPr marL="5950" marR="5950" marT="5950" marB="285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274</a:t>
                      </a:r>
                      <a:endParaRPr sz="1200" u="none" strike="noStrike" cap="none"/>
                    </a:p>
                  </a:txBody>
                  <a:tcPr marL="5950" marR="5950" marT="5950" marB="28500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fr-FR" sz="1200" b="1" i="0" u="none" strike="noStrike" cap="none" dirty="0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85-3151</a:t>
                      </a:r>
                      <a:endParaRPr sz="1200" u="none" strike="noStrike" cap="none" dirty="0"/>
                    </a:p>
                  </a:txBody>
                  <a:tcPr marL="5950" marR="5950" marT="5950" marB="28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8EB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1</Words>
  <Application>Microsoft Office PowerPoint</Application>
  <PresentationFormat>Grand écran</PresentationFormat>
  <Paragraphs>217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ylvain VRIGNON</dc:creator>
  <cp:lastModifiedBy>Anne PELLEGRINO</cp:lastModifiedBy>
  <cp:revision>1</cp:revision>
  <dcterms:created xsi:type="dcterms:W3CDTF">2024-09-17T14:08:20Z</dcterms:created>
  <dcterms:modified xsi:type="dcterms:W3CDTF">2024-09-27T12:22:54Z</dcterms:modified>
</cp:coreProperties>
</file>